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6" autoAdjust="0"/>
    <p:restoredTop sz="94660"/>
  </p:normalViewPr>
  <p:slideViewPr>
    <p:cSldViewPr snapToGrid="0">
      <p:cViewPr varScale="1">
        <p:scale>
          <a:sx n="84" d="100"/>
          <a:sy n="84" d="100"/>
        </p:scale>
        <p:origin x="571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B950F7C-8637-47E7-BB22-75A87AA76F5F}" type="datetimeFigureOut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8/04/2019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850D4A3-5D10-4C8B-AC85-8841A5787DCE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81789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B950F7C-8637-47E7-BB22-75A87AA76F5F}" type="datetimeFigureOut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8/04/2019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850D4A3-5D10-4C8B-AC85-8841A5787DCE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227926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B950F7C-8637-47E7-BB22-75A87AA76F5F}" type="datetimeFigureOut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8/04/2019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850D4A3-5D10-4C8B-AC85-8841A5787DCE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85248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B950F7C-8637-47E7-BB22-75A87AA76F5F}" type="datetimeFigureOut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8/04/2019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850D4A3-5D10-4C8B-AC85-8841A5787DCE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61773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B950F7C-8637-47E7-BB22-75A87AA76F5F}" type="datetimeFigureOut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8/04/2019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850D4A3-5D10-4C8B-AC85-8841A5787DCE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57577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B950F7C-8637-47E7-BB22-75A87AA76F5F}" type="datetimeFigureOut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8/04/2019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850D4A3-5D10-4C8B-AC85-8841A5787DCE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30114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B950F7C-8637-47E7-BB22-75A87AA76F5F}" type="datetimeFigureOut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8/04/2019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850D4A3-5D10-4C8B-AC85-8841A5787DCE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92227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B950F7C-8637-47E7-BB22-75A87AA76F5F}" type="datetimeFigureOut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8/04/2019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850D4A3-5D10-4C8B-AC85-8841A5787DCE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63040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B950F7C-8637-47E7-BB22-75A87AA76F5F}" type="datetimeFigureOut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8/04/2019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850D4A3-5D10-4C8B-AC85-8841A5787DCE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3552818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B950F7C-8637-47E7-BB22-75A87AA76F5F}" type="datetimeFigureOut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8/04/2019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850D4A3-5D10-4C8B-AC85-8841A5787DCE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76576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B950F7C-8637-47E7-BB22-75A87AA76F5F}" type="datetimeFigureOut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8/04/2019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850D4A3-5D10-4C8B-AC85-8841A5787DCE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32974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B950F7C-8637-47E7-BB22-75A87AA76F5F}" type="datetimeFigureOut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8/04/2019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850D4A3-5D10-4C8B-AC85-8841A5787DCE}" type="slidenum">
              <a:rPr kumimoji="0" lang="fr-FR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N°›</a:t>
            </a:fld>
            <a:endParaRPr kumimoji="0" lang="fr-FR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4150136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ZoneTexte 11"/>
          <p:cNvSpPr txBox="1"/>
          <p:nvPr/>
        </p:nvSpPr>
        <p:spPr>
          <a:xfrm>
            <a:off x="464496" y="3759320"/>
            <a:ext cx="2155134" cy="92333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9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primer pairs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roduce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no </a:t>
            </a:r>
            <a:r>
              <a:rPr kumimoji="0" lang="fr-F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plification</a:t>
            </a: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2993175" y="3759320"/>
            <a:ext cx="2015606" cy="120032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5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primer pairs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enerate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PCR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roduct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of more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than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300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p</a:t>
            </a: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7305696" y="3759320"/>
            <a:ext cx="2224682" cy="92333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3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primer pairs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roduce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a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ultiloci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profile</a:t>
            </a: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5244243" y="3759320"/>
            <a:ext cx="1854200" cy="120032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4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primer pairs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roduce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onomorphic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amplification</a:t>
            </a: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9937622" y="3759320"/>
            <a:ext cx="1854200" cy="120032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53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primer pairs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mplified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a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olymorphic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ragment </a:t>
            </a: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17" name="ZoneTexte 16"/>
          <p:cNvSpPr txBox="1"/>
          <p:nvPr/>
        </p:nvSpPr>
        <p:spPr>
          <a:xfrm>
            <a:off x="4721578" y="2533295"/>
            <a:ext cx="287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creening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ith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5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enotypes</a:t>
            </a: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24" name="ZoneTexte 23"/>
          <p:cNvSpPr txBox="1"/>
          <p:nvPr/>
        </p:nvSpPr>
        <p:spPr>
          <a:xfrm>
            <a:off x="4112754" y="5830080"/>
            <a:ext cx="2834698" cy="92333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8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SRs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out of the 53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ere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elected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and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used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in population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enetics</a:t>
            </a: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7" name="Rectangle avec flèche vers le bas 6"/>
          <p:cNvSpPr/>
          <p:nvPr/>
        </p:nvSpPr>
        <p:spPr>
          <a:xfrm>
            <a:off x="379059" y="132588"/>
            <a:ext cx="11577809" cy="1121321"/>
          </a:xfrm>
          <a:prstGeom prst="downArrowCallout">
            <a:avLst>
              <a:gd name="adj1" fmla="val 14127"/>
              <a:gd name="adj2" fmla="val 19564"/>
              <a:gd name="adj3" fmla="val 25000"/>
              <a:gd name="adj4" fmla="val 55895"/>
            </a:avLst>
          </a:prstGeom>
          <a:solidFill>
            <a:schemeClr val="accent1">
              <a:lumMod val="20000"/>
              <a:lumOff val="80000"/>
            </a:schemeClr>
          </a:solidFill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060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SRs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oci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fr-FR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itable</a:t>
            </a:r>
            <a:r>
              <a:rPr kumimoji="0" lang="fr-F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for primer design in 150,280 </a:t>
            </a:r>
            <a:r>
              <a:rPr kumimoji="0" lang="fr-FR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unigenes</a:t>
            </a: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37" name="Rectangle avec flèche vers le bas 36"/>
          <p:cNvSpPr/>
          <p:nvPr/>
        </p:nvSpPr>
        <p:spPr>
          <a:xfrm>
            <a:off x="3590102" y="1360028"/>
            <a:ext cx="5003075" cy="1121321"/>
          </a:xfrm>
          <a:prstGeom prst="downArrowCallout">
            <a:avLst>
              <a:gd name="adj1" fmla="val 14127"/>
              <a:gd name="adj2" fmla="val 19564"/>
              <a:gd name="adj3" fmla="val 25000"/>
              <a:gd name="adj4" fmla="val 55895"/>
            </a:avLst>
          </a:prstGeom>
          <a:solidFill>
            <a:schemeClr val="accent1">
              <a:lumMod val="20000"/>
              <a:lumOff val="80000"/>
            </a:schemeClr>
          </a:solidFill>
          <a:effectLst>
            <a:outerShdw blurRad="50800" dist="38100" dir="8100000" algn="tr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120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94 </a:t>
            </a:r>
            <a:r>
              <a:rPr kumimoji="0" lang="fr-FR" sz="18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SRs</a:t>
            </a:r>
            <a:r>
              <a:rPr kumimoji="0" lang="fr-FR" sz="18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fr-FR" sz="18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loci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ith</a:t>
            </a:r>
            <a:r>
              <a:rPr kumimoji="0" lang="fr-F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epeat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fr-FR" sz="18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between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10 and 26 </a:t>
            </a:r>
            <a:r>
              <a:rPr kumimoji="0" lang="fr-FR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ere</a:t>
            </a:r>
            <a:r>
              <a:rPr kumimoji="0" lang="fr-F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fr-FR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elected</a:t>
            </a:r>
            <a:r>
              <a:rPr kumimoji="0" lang="fr-FR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to </a:t>
            </a:r>
            <a:r>
              <a:rPr kumimoji="0" lang="fr-FR" sz="18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esign </a:t>
            </a:r>
            <a:r>
              <a:rPr kumimoji="0" lang="fr-FR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rimers</a:t>
            </a: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28" name="Connecteur droit 27"/>
          <p:cNvCxnSpPr/>
          <p:nvPr/>
        </p:nvCxnSpPr>
        <p:spPr>
          <a:xfrm>
            <a:off x="6100265" y="2902627"/>
            <a:ext cx="0" cy="645681"/>
          </a:xfrm>
          <a:prstGeom prst="line">
            <a:avLst/>
          </a:prstGeom>
          <a:ln w="38100"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cteur droit 32"/>
          <p:cNvCxnSpPr/>
          <p:nvPr/>
        </p:nvCxnSpPr>
        <p:spPr>
          <a:xfrm>
            <a:off x="1456627" y="3535681"/>
            <a:ext cx="9408095" cy="12627"/>
          </a:xfrm>
          <a:prstGeom prst="line">
            <a:avLst/>
          </a:prstGeom>
          <a:ln w="38100"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necteur droit avec flèche 59"/>
          <p:cNvCxnSpPr/>
          <p:nvPr/>
        </p:nvCxnSpPr>
        <p:spPr>
          <a:xfrm>
            <a:off x="6100265" y="3528782"/>
            <a:ext cx="338" cy="230538"/>
          </a:xfrm>
          <a:prstGeom prst="straightConnector1">
            <a:avLst/>
          </a:prstGeom>
          <a:ln w="38100">
            <a:solidFill>
              <a:schemeClr val="accent1">
                <a:lumMod val="60000"/>
                <a:lumOff val="4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necteur droit avec flèche 62"/>
          <p:cNvCxnSpPr/>
          <p:nvPr/>
        </p:nvCxnSpPr>
        <p:spPr>
          <a:xfrm>
            <a:off x="8452827" y="3528782"/>
            <a:ext cx="658" cy="230538"/>
          </a:xfrm>
          <a:prstGeom prst="straightConnector1">
            <a:avLst/>
          </a:prstGeom>
          <a:ln w="38100">
            <a:solidFill>
              <a:schemeClr val="accent1">
                <a:lumMod val="60000"/>
                <a:lumOff val="4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necteur droit avec flèche 63"/>
          <p:cNvCxnSpPr/>
          <p:nvPr/>
        </p:nvCxnSpPr>
        <p:spPr>
          <a:xfrm>
            <a:off x="3915035" y="3528782"/>
            <a:ext cx="338" cy="230538"/>
          </a:xfrm>
          <a:prstGeom prst="straightConnector1">
            <a:avLst/>
          </a:prstGeom>
          <a:ln w="38100">
            <a:solidFill>
              <a:schemeClr val="accent1">
                <a:lumMod val="60000"/>
                <a:lumOff val="4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necteur droit avec flèche 64"/>
          <p:cNvCxnSpPr/>
          <p:nvPr/>
        </p:nvCxnSpPr>
        <p:spPr>
          <a:xfrm>
            <a:off x="1473616" y="3528782"/>
            <a:ext cx="338" cy="230538"/>
          </a:xfrm>
          <a:prstGeom prst="straightConnector1">
            <a:avLst/>
          </a:prstGeom>
          <a:ln w="38100">
            <a:solidFill>
              <a:schemeClr val="accent1">
                <a:lumMod val="60000"/>
                <a:lumOff val="4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necteur droit avec flèche 65"/>
          <p:cNvCxnSpPr/>
          <p:nvPr/>
        </p:nvCxnSpPr>
        <p:spPr>
          <a:xfrm>
            <a:off x="10849978" y="3528782"/>
            <a:ext cx="658" cy="230538"/>
          </a:xfrm>
          <a:prstGeom prst="straightConnector1">
            <a:avLst/>
          </a:prstGeom>
          <a:ln w="38100">
            <a:solidFill>
              <a:schemeClr val="accent1">
                <a:lumMod val="60000"/>
                <a:lumOff val="4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Rectangle à coins arrondis 67"/>
          <p:cNvSpPr/>
          <p:nvPr/>
        </p:nvSpPr>
        <p:spPr>
          <a:xfrm>
            <a:off x="9777465" y="3686982"/>
            <a:ext cx="2174513" cy="1410783"/>
          </a:xfrm>
          <a:prstGeom prst="roundRect">
            <a:avLst/>
          </a:prstGeom>
          <a:noFill/>
          <a:ln w="12700">
            <a:solidFill>
              <a:schemeClr val="accent1">
                <a:lumMod val="20000"/>
                <a:lumOff val="80000"/>
              </a:schemeClr>
            </a:solidFill>
          </a:ln>
          <a:effectLst>
            <a:glow rad="101600">
              <a:schemeClr val="accent5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fr-FR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cxnSp>
        <p:nvCxnSpPr>
          <p:cNvPr id="70" name="Connecteur droit avec flèche 69"/>
          <p:cNvCxnSpPr/>
          <p:nvPr/>
        </p:nvCxnSpPr>
        <p:spPr>
          <a:xfrm flipH="1">
            <a:off x="7098444" y="5106838"/>
            <a:ext cx="2431934" cy="746500"/>
          </a:xfrm>
          <a:prstGeom prst="straightConnector1">
            <a:avLst/>
          </a:prstGeom>
          <a:ln w="38100">
            <a:solidFill>
              <a:schemeClr val="accent1">
                <a:lumMod val="60000"/>
                <a:lumOff val="4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371668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07097" y="467091"/>
            <a:ext cx="6053853" cy="2840982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07097" y="3705812"/>
            <a:ext cx="6053853" cy="2755631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 rot="16200000">
            <a:off x="476442" y="4822016"/>
            <a:ext cx="275563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ean</a:t>
            </a:r>
            <a:r>
              <a:rPr kumimoji="0" lang="fr-FR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fr-FR" sz="14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umber</a:t>
            </a:r>
            <a:r>
              <a:rPr kumimoji="0" lang="fr-FR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of distinct </a:t>
            </a:r>
            <a:r>
              <a:rPr kumimoji="0" lang="fr-FR" sz="14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lleles</a:t>
            </a:r>
            <a:r>
              <a:rPr kumimoji="0" lang="fr-FR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per locu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 rot="16200000">
            <a:off x="438455" y="1625972"/>
            <a:ext cx="284098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4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ean</a:t>
            </a:r>
            <a:r>
              <a:rPr kumimoji="0" lang="fr-FR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fr-FR" sz="14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number</a:t>
            </a:r>
            <a:r>
              <a:rPr kumimoji="0" lang="fr-FR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of </a:t>
            </a:r>
            <a:r>
              <a:rPr kumimoji="0" lang="fr-FR" sz="14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private</a:t>
            </a:r>
            <a:r>
              <a:rPr kumimoji="0" lang="fr-FR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fr-FR" sz="14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lleles</a:t>
            </a:r>
            <a:r>
              <a:rPr kumimoji="0" lang="fr-FR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per locu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4345577" y="6461442"/>
            <a:ext cx="14654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ample</a:t>
            </a:r>
            <a:r>
              <a:rPr kumimoji="0" lang="fr-FR" sz="16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size (g)</a:t>
            </a:r>
            <a:endParaRPr kumimoji="0" 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2929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7</Words>
  <Application>Microsoft Office PowerPoint</Application>
  <PresentationFormat>Grand écran</PresentationFormat>
  <Paragraphs>14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1_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alerie Schurdi-Levraud</dc:creator>
  <cp:lastModifiedBy>Valerie Schurdi-Levraud</cp:lastModifiedBy>
  <cp:revision>1</cp:revision>
  <dcterms:created xsi:type="dcterms:W3CDTF">2019-04-28T13:33:50Z</dcterms:created>
  <dcterms:modified xsi:type="dcterms:W3CDTF">2019-04-28T13:34:11Z</dcterms:modified>
</cp:coreProperties>
</file>